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D23A-B588-441A-88BD-A90C81616E1E}" type="datetimeFigureOut">
              <a:rPr lang="en-US" smtClean="0"/>
              <a:t>5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1A18B-C99F-4BB5-AFCA-D20612686E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113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D23A-B588-441A-88BD-A90C81616E1E}" type="datetimeFigureOut">
              <a:rPr lang="en-US" smtClean="0"/>
              <a:t>5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1A18B-C99F-4BB5-AFCA-D20612686E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0890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D23A-B588-441A-88BD-A90C81616E1E}" type="datetimeFigureOut">
              <a:rPr lang="en-US" smtClean="0"/>
              <a:t>5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1A18B-C99F-4BB5-AFCA-D20612686E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653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D23A-B588-441A-88BD-A90C81616E1E}" type="datetimeFigureOut">
              <a:rPr lang="en-US" smtClean="0"/>
              <a:t>5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1A18B-C99F-4BB5-AFCA-D20612686E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17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D23A-B588-441A-88BD-A90C81616E1E}" type="datetimeFigureOut">
              <a:rPr lang="en-US" smtClean="0"/>
              <a:t>5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1A18B-C99F-4BB5-AFCA-D20612686E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8197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D23A-B588-441A-88BD-A90C81616E1E}" type="datetimeFigureOut">
              <a:rPr lang="en-US" smtClean="0"/>
              <a:t>5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1A18B-C99F-4BB5-AFCA-D20612686E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215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D23A-B588-441A-88BD-A90C81616E1E}" type="datetimeFigureOut">
              <a:rPr lang="en-US" smtClean="0"/>
              <a:t>5/1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1A18B-C99F-4BB5-AFCA-D20612686E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077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D23A-B588-441A-88BD-A90C81616E1E}" type="datetimeFigureOut">
              <a:rPr lang="en-US" smtClean="0"/>
              <a:t>5/1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1A18B-C99F-4BB5-AFCA-D20612686E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567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D23A-B588-441A-88BD-A90C81616E1E}" type="datetimeFigureOut">
              <a:rPr lang="en-US" smtClean="0"/>
              <a:t>5/1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1A18B-C99F-4BB5-AFCA-D20612686E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824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D23A-B588-441A-88BD-A90C81616E1E}" type="datetimeFigureOut">
              <a:rPr lang="en-US" smtClean="0"/>
              <a:t>5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1A18B-C99F-4BB5-AFCA-D20612686E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128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D23A-B588-441A-88BD-A90C81616E1E}" type="datetimeFigureOut">
              <a:rPr lang="en-US" smtClean="0"/>
              <a:t>5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1A18B-C99F-4BB5-AFCA-D20612686E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903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B3D23A-B588-441A-88BD-A90C81616E1E}" type="datetimeFigureOut">
              <a:rPr lang="en-US" smtClean="0"/>
              <a:t>5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B1A18B-C99F-4BB5-AFCA-D20612686E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089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0612"/>
          <a:stretch/>
        </p:blipFill>
        <p:spPr bwMode="auto">
          <a:xfrm>
            <a:off x="304800" y="2133600"/>
            <a:ext cx="6400800" cy="5680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639"/>
          <a:stretch/>
        </p:blipFill>
        <p:spPr bwMode="auto">
          <a:xfrm>
            <a:off x="1752600" y="3693226"/>
            <a:ext cx="3095625" cy="3126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905000" y="3320534"/>
            <a:ext cx="30364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    2    3    4     5    6    7    8    9 </a:t>
            </a:r>
            <a:endParaRPr lang="en-US" dirty="0"/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1219200" y="6400800"/>
            <a:ext cx="457200" cy="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1219200" y="4686547"/>
            <a:ext cx="457200" cy="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1219200" y="5181600"/>
            <a:ext cx="457200" cy="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1219200" y="5486400"/>
            <a:ext cx="457200" cy="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1219200" y="5867400"/>
            <a:ext cx="457200" cy="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1219200" y="4267200"/>
            <a:ext cx="457200" cy="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1219200" y="4038600"/>
            <a:ext cx="457200" cy="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1219200" y="3810000"/>
            <a:ext cx="457200" cy="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575331" y="6245423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0.25 kb</a:t>
            </a:r>
            <a:endParaRPr lang="en-US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621016" y="5713511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0.5 kb</a:t>
            </a:r>
            <a:endParaRPr lang="en-US" sz="1400" dirty="0"/>
          </a:p>
        </p:txBody>
      </p:sp>
      <p:sp>
        <p:nvSpPr>
          <p:cNvPr id="23" name="TextBox 22"/>
          <p:cNvSpPr txBox="1"/>
          <p:nvPr/>
        </p:nvSpPr>
        <p:spPr>
          <a:xfrm>
            <a:off x="575331" y="5332511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0.75 kb</a:t>
            </a:r>
            <a:endParaRPr lang="en-US" sz="1400" dirty="0"/>
          </a:p>
        </p:txBody>
      </p:sp>
      <p:sp>
        <p:nvSpPr>
          <p:cNvPr id="24" name="TextBox 23"/>
          <p:cNvSpPr txBox="1"/>
          <p:nvPr/>
        </p:nvSpPr>
        <p:spPr>
          <a:xfrm>
            <a:off x="621016" y="5027711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1.0 kb</a:t>
            </a:r>
            <a:endParaRPr lang="en-US" sz="1400" dirty="0"/>
          </a:p>
        </p:txBody>
      </p:sp>
      <p:sp>
        <p:nvSpPr>
          <p:cNvPr id="25" name="TextBox 24"/>
          <p:cNvSpPr txBox="1"/>
          <p:nvPr/>
        </p:nvSpPr>
        <p:spPr>
          <a:xfrm>
            <a:off x="621016" y="4532658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1.5 kb</a:t>
            </a:r>
            <a:endParaRPr lang="en-US" sz="1400" dirty="0"/>
          </a:p>
        </p:txBody>
      </p:sp>
      <p:sp>
        <p:nvSpPr>
          <p:cNvPr id="26" name="TextBox 25"/>
          <p:cNvSpPr txBox="1"/>
          <p:nvPr/>
        </p:nvSpPr>
        <p:spPr>
          <a:xfrm>
            <a:off x="621016" y="4113311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2.0 kb</a:t>
            </a:r>
            <a:endParaRPr lang="en-US" sz="1400" dirty="0"/>
          </a:p>
        </p:txBody>
      </p:sp>
      <p:sp>
        <p:nvSpPr>
          <p:cNvPr id="27" name="TextBox 26"/>
          <p:cNvSpPr txBox="1"/>
          <p:nvPr/>
        </p:nvSpPr>
        <p:spPr>
          <a:xfrm>
            <a:off x="621016" y="3884711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2.5 kb</a:t>
            </a:r>
            <a:endParaRPr lang="en-US" sz="1400" dirty="0"/>
          </a:p>
        </p:txBody>
      </p:sp>
      <p:sp>
        <p:nvSpPr>
          <p:cNvPr id="28" name="TextBox 27"/>
          <p:cNvSpPr txBox="1"/>
          <p:nvPr/>
        </p:nvSpPr>
        <p:spPr>
          <a:xfrm>
            <a:off x="621016" y="3654623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</a:t>
            </a:r>
            <a:r>
              <a:rPr lang="en-US" sz="1400" dirty="0" smtClean="0"/>
              <a:t>.0 kb</a:t>
            </a:r>
            <a:endParaRPr lang="en-US" sz="1400" dirty="0"/>
          </a:p>
        </p:txBody>
      </p:sp>
      <p:sp>
        <p:nvSpPr>
          <p:cNvPr id="9" name="Rectangle 8"/>
          <p:cNvSpPr/>
          <p:nvPr/>
        </p:nvSpPr>
        <p:spPr>
          <a:xfrm>
            <a:off x="304800" y="7145400"/>
            <a:ext cx="63627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Southern analysis of double cross-overs. </a:t>
            </a:r>
          </a:p>
          <a:p>
            <a:endParaRPr 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veral DCO strains were selected for analysis. Genomic DNA was isolated, digested with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mHI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separated on an 0.8% w/v agarose gel, transferred to a blotting membrane and probed with cyp125 (PCR product generated using primers D1 and D2). The wild-type genomic restriction map and Southern probe is shown. Expected sizes for the wild-type were 2.2, 1.8 and 0.4 kb (double band). Expected sizes for the deletion were 2.0 and 1.6 kb. Lanes 3,6,7,0 had deletion alleles. Lanes 2,4,5,8 had wild-type alleles. Lane 1 – 1 kb markers. The strain from Lane 3 was selected for studie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5552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46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nya Parish</dc:creator>
  <cp:lastModifiedBy>Tanya Parish</cp:lastModifiedBy>
  <cp:revision>5</cp:revision>
  <dcterms:created xsi:type="dcterms:W3CDTF">2015-05-18T15:22:40Z</dcterms:created>
  <dcterms:modified xsi:type="dcterms:W3CDTF">2015-05-18T15:33:28Z</dcterms:modified>
</cp:coreProperties>
</file>